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99" d="100"/>
          <a:sy n="99" d="100"/>
        </p:scale>
        <p:origin x="-780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8D816-08C2-4EBC-98EC-4CC5391AB920}" type="datetimeFigureOut">
              <a:rPr lang="it-IT" smtClean="0"/>
              <a:t>17/10/201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F6D3BC-6163-4A38-AFAF-BA3057FB887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422636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8D816-08C2-4EBC-98EC-4CC5391AB920}" type="datetimeFigureOut">
              <a:rPr lang="it-IT" smtClean="0"/>
              <a:t>17/10/201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F6D3BC-6163-4A38-AFAF-BA3057FB887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290961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8D816-08C2-4EBC-98EC-4CC5391AB920}" type="datetimeFigureOut">
              <a:rPr lang="it-IT" smtClean="0"/>
              <a:t>17/10/201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F6D3BC-6163-4A38-AFAF-BA3057FB887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136210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8D816-08C2-4EBC-98EC-4CC5391AB920}" type="datetimeFigureOut">
              <a:rPr lang="it-IT" smtClean="0"/>
              <a:t>17/10/201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F6D3BC-6163-4A38-AFAF-BA3057FB887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840080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8D816-08C2-4EBC-98EC-4CC5391AB920}" type="datetimeFigureOut">
              <a:rPr lang="it-IT" smtClean="0"/>
              <a:t>17/10/201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F6D3BC-6163-4A38-AFAF-BA3057FB887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367670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8D816-08C2-4EBC-98EC-4CC5391AB920}" type="datetimeFigureOut">
              <a:rPr lang="it-IT" smtClean="0"/>
              <a:t>17/10/2012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F6D3BC-6163-4A38-AFAF-BA3057FB887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810834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8D816-08C2-4EBC-98EC-4CC5391AB920}" type="datetimeFigureOut">
              <a:rPr lang="it-IT" smtClean="0"/>
              <a:t>17/10/2012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F6D3BC-6163-4A38-AFAF-BA3057FB887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674572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8D816-08C2-4EBC-98EC-4CC5391AB920}" type="datetimeFigureOut">
              <a:rPr lang="it-IT" smtClean="0"/>
              <a:t>17/10/2012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F6D3BC-6163-4A38-AFAF-BA3057FB887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257829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8D816-08C2-4EBC-98EC-4CC5391AB920}" type="datetimeFigureOut">
              <a:rPr lang="it-IT" smtClean="0"/>
              <a:t>17/10/2012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F6D3BC-6163-4A38-AFAF-BA3057FB887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202367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8D816-08C2-4EBC-98EC-4CC5391AB920}" type="datetimeFigureOut">
              <a:rPr lang="it-IT" smtClean="0"/>
              <a:t>17/10/2012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F6D3BC-6163-4A38-AFAF-BA3057FB887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3683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8D816-08C2-4EBC-98EC-4CC5391AB920}" type="datetimeFigureOut">
              <a:rPr lang="it-IT" smtClean="0"/>
              <a:t>17/10/2012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F6D3BC-6163-4A38-AFAF-BA3057FB887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24872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08D816-08C2-4EBC-98EC-4CC5391AB920}" type="datetimeFigureOut">
              <a:rPr lang="it-IT" smtClean="0"/>
              <a:t>17/10/201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F6D3BC-6163-4A38-AFAF-BA3057FB887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78266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6" name="Immagine 6" descr="deltaK.eps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736"/>
          <a:stretch>
            <a:fillRect/>
          </a:stretch>
        </p:blipFill>
        <p:spPr bwMode="auto">
          <a:xfrm>
            <a:off x="4903788" y="455613"/>
            <a:ext cx="4179887" cy="3433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387" name="Immagine 7" descr="meanLnProb(1).eps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704"/>
          <a:stretch>
            <a:fillRect/>
          </a:stretch>
        </p:blipFill>
        <p:spPr bwMode="auto">
          <a:xfrm>
            <a:off x="493713" y="455613"/>
            <a:ext cx="4179887" cy="3433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6388" name="CasellaDiTesto 8"/>
          <p:cNvSpPr txBox="1">
            <a:spLocks noChangeArrowheads="1"/>
          </p:cNvSpPr>
          <p:nvPr/>
        </p:nvSpPr>
        <p:spPr bwMode="auto">
          <a:xfrm>
            <a:off x="3983038" y="66675"/>
            <a:ext cx="1090612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it-IT" sz="1800">
                <a:latin typeface="Calibri" charset="0"/>
              </a:rPr>
              <a:t> SSRs</a:t>
            </a:r>
          </a:p>
        </p:txBody>
      </p:sp>
      <p:sp>
        <p:nvSpPr>
          <p:cNvPr id="16389" name="CasellaDiTesto 9"/>
          <p:cNvSpPr txBox="1">
            <a:spLocks noChangeArrowheads="1"/>
          </p:cNvSpPr>
          <p:nvPr/>
        </p:nvSpPr>
        <p:spPr bwMode="auto">
          <a:xfrm>
            <a:off x="0" y="609600"/>
            <a:ext cx="493713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it-IT" sz="1800">
                <a:latin typeface="Calibri" charset="0"/>
              </a:rPr>
              <a:t>a)</a:t>
            </a:r>
          </a:p>
        </p:txBody>
      </p:sp>
      <p:sp>
        <p:nvSpPr>
          <p:cNvPr id="16390" name="CasellaDiTesto 10"/>
          <p:cNvSpPr txBox="1">
            <a:spLocks noChangeArrowheads="1"/>
          </p:cNvSpPr>
          <p:nvPr/>
        </p:nvSpPr>
        <p:spPr bwMode="auto">
          <a:xfrm>
            <a:off x="4776788" y="538163"/>
            <a:ext cx="493712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it-IT" sz="1800">
                <a:latin typeface="Calibri" charset="0"/>
              </a:rPr>
              <a:t>b)</a:t>
            </a:r>
          </a:p>
        </p:txBody>
      </p:sp>
      <p:sp>
        <p:nvSpPr>
          <p:cNvPr id="16391" name="CasellaDiTesto 11"/>
          <p:cNvSpPr txBox="1">
            <a:spLocks noChangeArrowheads="1"/>
          </p:cNvSpPr>
          <p:nvPr/>
        </p:nvSpPr>
        <p:spPr bwMode="auto">
          <a:xfrm>
            <a:off x="0" y="3962400"/>
            <a:ext cx="493713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it-IT" sz="1800">
                <a:latin typeface="Calibri" charset="0"/>
              </a:rPr>
              <a:t>c)</a:t>
            </a:r>
          </a:p>
        </p:txBody>
      </p:sp>
      <p:sp>
        <p:nvSpPr>
          <p:cNvPr id="16392" name="CasellaDiTesto 13"/>
          <p:cNvSpPr txBox="1">
            <a:spLocks noChangeArrowheads="1"/>
          </p:cNvSpPr>
          <p:nvPr/>
        </p:nvSpPr>
        <p:spPr bwMode="auto">
          <a:xfrm rot="-5400000">
            <a:off x="-683419" y="2026444"/>
            <a:ext cx="2468563" cy="23177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algn="ctr" eaLnBrk="1" hangingPunct="1"/>
            <a:r>
              <a:rPr lang="it-IT" sz="800" dirty="0" err="1">
                <a:latin typeface="Calibri" charset="0"/>
              </a:rPr>
              <a:t>Mean</a:t>
            </a:r>
            <a:r>
              <a:rPr lang="it-IT" sz="900" dirty="0">
                <a:latin typeface="Calibri" charset="0"/>
              </a:rPr>
              <a:t> </a:t>
            </a:r>
            <a:r>
              <a:rPr lang="it-IT" sz="900" dirty="0" smtClean="0">
                <a:latin typeface="Calibri" charset="0"/>
              </a:rPr>
              <a:t>L(K</a:t>
            </a:r>
            <a:r>
              <a:rPr lang="it-IT" sz="900" dirty="0">
                <a:latin typeface="Calibri" charset="0"/>
              </a:rPr>
              <a:t>)</a:t>
            </a:r>
          </a:p>
        </p:txBody>
      </p:sp>
      <p:graphicFrame>
        <p:nvGraphicFramePr>
          <p:cNvPr id="10" name="Tabella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28626600"/>
              </p:ext>
            </p:extLst>
          </p:nvPr>
        </p:nvGraphicFramePr>
        <p:xfrm>
          <a:off x="998538" y="4160838"/>
          <a:ext cx="7467600" cy="2561590"/>
        </p:xfrm>
        <a:graphic>
          <a:graphicData uri="http://schemas.openxmlformats.org/drawingml/2006/table">
            <a:tbl>
              <a:tblPr/>
              <a:tblGrid>
                <a:gridCol w="688975"/>
                <a:gridCol w="561651"/>
                <a:gridCol w="773436"/>
                <a:gridCol w="868363"/>
                <a:gridCol w="777875"/>
                <a:gridCol w="866775"/>
                <a:gridCol w="866775"/>
                <a:gridCol w="688975"/>
                <a:gridCol w="687387"/>
                <a:gridCol w="687388"/>
              </a:tblGrid>
              <a:tr h="100013">
                <a:tc rowSpan="2"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1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Number</a:t>
                      </a:r>
                      <a:r>
                        <a:rPr kumimoji="0" lang="it-IT" sz="7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 of cluster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1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Number</a:t>
                      </a:r>
                      <a:r>
                        <a:rPr kumimoji="0" lang="it-IT" sz="7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 of </a:t>
                      </a:r>
                      <a:r>
                        <a:rPr kumimoji="0" lang="it-IT" sz="700" b="1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runs</a:t>
                      </a:r>
                      <a:endParaRPr kumimoji="0" lang="it-IT" sz="7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-128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L(K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ΔK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Wilcoxon significance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Similarity coefficient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Clusteredness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</a:tr>
              <a:tr h="307975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mean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standard dev.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mean similarity coeff.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standard dev.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mean clusteredness coeff.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standard dev.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0013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101286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19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0013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2*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9440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44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8059.36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p &lt; 0.0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99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90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0013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9217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4.08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446.37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p &lt; 0.0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99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77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0013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9149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30.01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.04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p &lt; 0.0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93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6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75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2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0013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905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3.48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48.22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p &lt; 0.0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99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0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71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0013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6</a:t>
                      </a:r>
                      <a:r>
                        <a:rPr kumimoji="0" lang="it-IT" sz="7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#</a:t>
                      </a:r>
                      <a:endParaRPr kumimoji="0" lang="it-IT" sz="7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-128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8983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4.96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31.77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p &lt; 0.0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76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29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71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0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0013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8927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95.31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.02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ns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47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28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71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1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0013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8919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271.08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.84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ns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54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30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70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2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0013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909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2739.55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.49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ns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78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23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68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0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0013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8844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20.62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3.93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ns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84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16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69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2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0013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8865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299.11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53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ns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65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18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69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0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0013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8981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2697.01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.57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ns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80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19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69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1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0013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8879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565.54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.25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ns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71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22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69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0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0013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8899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893.46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55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ns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91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8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69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0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0013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8866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42.76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.28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ns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96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2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69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0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0013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9061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4272.89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96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ns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87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13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69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1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0013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9114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5349.72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.03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ns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74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12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68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1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0013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8995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2450.17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62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ns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85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16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69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1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0013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8895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37.19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52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ns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82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18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69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0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7950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2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8902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294.59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ns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96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3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69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0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45925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5</Words>
  <Application>Microsoft Office PowerPoint</Application>
  <PresentationFormat>Presentazione su schermo (4:3)</PresentationFormat>
  <Paragraphs>218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Company>FE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rancesco emanuelli</dc:creator>
  <cp:lastModifiedBy>francesco emanuelli</cp:lastModifiedBy>
  <cp:revision>2</cp:revision>
  <dcterms:created xsi:type="dcterms:W3CDTF">2012-10-17T13:23:48Z</dcterms:created>
  <dcterms:modified xsi:type="dcterms:W3CDTF">2012-10-17T13:24:06Z</dcterms:modified>
</cp:coreProperties>
</file>